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44" autoAdjust="0"/>
    <p:restoredTop sz="94660"/>
  </p:normalViewPr>
  <p:slideViewPr>
    <p:cSldViewPr snapToGrid="0">
      <p:cViewPr varScale="1">
        <p:scale>
          <a:sx n="43" d="100"/>
          <a:sy n="43" d="100"/>
        </p:scale>
        <p:origin x="822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6350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9747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7418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9226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5719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2074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9891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54971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4657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321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2037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20584-BDF0-45B0-B3FD-C0E4E758B661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13/11/29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BF2FC-214B-49D2-84AD-E00700551C53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40984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2"/>
          <a:srcRect t="1037" r="947"/>
          <a:stretch/>
        </p:blipFill>
        <p:spPr>
          <a:xfrm>
            <a:off x="2044019" y="195943"/>
            <a:ext cx="7591308" cy="6016076"/>
          </a:xfrm>
          <a:prstGeom prst="rect">
            <a:avLst/>
          </a:prstGeom>
        </p:spPr>
      </p:pic>
      <p:cxnSp>
        <p:nvCxnSpPr>
          <p:cNvPr id="3" name="直線接點 2"/>
          <p:cNvCxnSpPr/>
          <p:nvPr/>
        </p:nvCxnSpPr>
        <p:spPr>
          <a:xfrm>
            <a:off x="9434783" y="302079"/>
            <a:ext cx="0" cy="1592035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字方塊 4"/>
          <p:cNvSpPr txBox="1"/>
          <p:nvPr/>
        </p:nvSpPr>
        <p:spPr>
          <a:xfrm>
            <a:off x="9453109" y="960583"/>
            <a:ext cx="267899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B5 </a:t>
            </a:r>
          </a:p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eage 1 (2008)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接點 5"/>
          <p:cNvCxnSpPr/>
          <p:nvPr/>
        </p:nvCxnSpPr>
        <p:spPr>
          <a:xfrm>
            <a:off x="9434784" y="1953050"/>
            <a:ext cx="6628" cy="716671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字方塊 6"/>
          <p:cNvSpPr txBox="1"/>
          <p:nvPr/>
        </p:nvSpPr>
        <p:spPr>
          <a:xfrm>
            <a:off x="9451520" y="2129605"/>
            <a:ext cx="189779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B5 </a:t>
            </a:r>
          </a:p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eage 2 (2012)</a:t>
            </a:r>
            <a:endParaRPr lang="zh-TW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171732" y="302079"/>
            <a:ext cx="3246402" cy="4385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2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TW" altLang="en-US" sz="225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7881961" y="1782508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3.82</a:t>
            </a:r>
            <a:endParaRPr lang="zh-TW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8193784" y="2351726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10.44</a:t>
            </a:r>
            <a:endParaRPr lang="zh-TW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7935749" y="1264476"/>
            <a:ext cx="6431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4.31</a:t>
            </a:r>
            <a:endParaRPr lang="zh-TW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接點 12"/>
          <p:cNvCxnSpPr/>
          <p:nvPr/>
        </p:nvCxnSpPr>
        <p:spPr>
          <a:xfrm flipH="1">
            <a:off x="9084333" y="2695218"/>
            <a:ext cx="2" cy="295972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字方塊 13"/>
          <p:cNvSpPr txBox="1"/>
          <p:nvPr/>
        </p:nvSpPr>
        <p:spPr>
          <a:xfrm>
            <a:off x="9091409" y="2685400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4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接點 14"/>
          <p:cNvCxnSpPr/>
          <p:nvPr/>
        </p:nvCxnSpPr>
        <p:spPr>
          <a:xfrm>
            <a:off x="8130036" y="3014251"/>
            <a:ext cx="3743" cy="463210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字方塊 15"/>
          <p:cNvSpPr txBox="1"/>
          <p:nvPr/>
        </p:nvSpPr>
        <p:spPr>
          <a:xfrm>
            <a:off x="8094318" y="3081242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1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接點 16"/>
          <p:cNvCxnSpPr/>
          <p:nvPr/>
        </p:nvCxnSpPr>
        <p:spPr>
          <a:xfrm>
            <a:off x="9434516" y="4069683"/>
            <a:ext cx="267" cy="1773890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字方塊 17"/>
          <p:cNvSpPr txBox="1"/>
          <p:nvPr/>
        </p:nvSpPr>
        <p:spPr>
          <a:xfrm>
            <a:off x="9410403" y="4851401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4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接點 18"/>
          <p:cNvCxnSpPr/>
          <p:nvPr/>
        </p:nvCxnSpPr>
        <p:spPr>
          <a:xfrm>
            <a:off x="9282798" y="3521932"/>
            <a:ext cx="0" cy="529428"/>
          </a:xfrm>
          <a:prstGeom prst="line">
            <a:avLst/>
          </a:prstGeom>
          <a:ln w="12700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字方塊 19"/>
          <p:cNvSpPr txBox="1"/>
          <p:nvPr/>
        </p:nvSpPr>
        <p:spPr>
          <a:xfrm>
            <a:off x="9282798" y="3630574"/>
            <a:ext cx="19800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type </a:t>
            </a:r>
            <a:r>
              <a:rPr lang="en-US" altLang="zh-TW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en-US" altLang="zh-TW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8950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寬螢幕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1_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黃聖文</dc:creator>
  <cp:lastModifiedBy>黃聖文</cp:lastModifiedBy>
  <cp:revision>1</cp:revision>
  <dcterms:created xsi:type="dcterms:W3CDTF">2013-11-29T10:05:18Z</dcterms:created>
  <dcterms:modified xsi:type="dcterms:W3CDTF">2013-11-29T10:05:28Z</dcterms:modified>
</cp:coreProperties>
</file>